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5" autoAdjust="0"/>
    <p:restoredTop sz="94249" autoAdjust="0"/>
  </p:normalViewPr>
  <p:slideViewPr>
    <p:cSldViewPr snapToGrid="0">
      <p:cViewPr varScale="1">
        <p:scale>
          <a:sx n="105" d="100"/>
          <a:sy n="105" d="100"/>
        </p:scale>
        <p:origin x="1122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Steady%20State%20Conditions%20FB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Steady%20State%20Conditions%20FB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Steady%20State%20Conditions%20FB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Steady%20State%20Conditions%20FB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Steady%20State%20Conditions%20F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935673665791777"/>
          <c:y val="9.0033027294971354E-2"/>
          <c:w val="0.64453215223097116"/>
          <c:h val="0.699828939088741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KL, HSC'!$B$1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190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930E-45FE-B420-6884D093B45D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930E-45FE-B420-6884D093B45D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930E-45FE-B420-6884D093B45D}"/>
              </c:ext>
            </c:extLst>
          </c:dPt>
          <c:errBars>
            <c:errBarType val="plus"/>
            <c:errValType val="cust"/>
            <c:noEndCap val="0"/>
            <c:plus>
              <c:numRef>
                <c:f>'SKL, HSC'!$D$16:$E$16</c:f>
                <c:numCache>
                  <c:formatCode>General</c:formatCode>
                  <c:ptCount val="2"/>
                  <c:pt idx="0">
                    <c:v>0.17888133521666538</c:v>
                  </c:pt>
                  <c:pt idx="1">
                    <c:v>7.0209207777736342</c:v>
                  </c:pt>
                </c:numCache>
              </c:numRef>
            </c:plus>
            <c:minus>
              <c:numRef>
                <c:f>'SKL, HSC'!$D$16:$E$16</c:f>
                <c:numCache>
                  <c:formatCode>General</c:formatCode>
                  <c:ptCount val="2"/>
                  <c:pt idx="0">
                    <c:v>0.17888133521666538</c:v>
                  </c:pt>
                  <c:pt idx="1">
                    <c:v>7.0209207777736342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'!$D$14:$E$14</c:f>
              <c:strCache>
                <c:ptCount val="2"/>
                <c:pt idx="0">
                  <c:v>No. of SKL/µl PB</c:v>
                </c:pt>
                <c:pt idx="1">
                  <c:v>No. of HSC/µl PB</c:v>
                </c:pt>
              </c:strCache>
            </c:strRef>
          </c:cat>
          <c:val>
            <c:numRef>
              <c:f>'SKL, HSC'!$D$15:$E$15</c:f>
              <c:numCache>
                <c:formatCode>0</c:formatCode>
                <c:ptCount val="2"/>
                <c:pt idx="0" formatCode="0.00">
                  <c:v>1.4330978613147618</c:v>
                </c:pt>
                <c:pt idx="1">
                  <c:v>59.4066096986103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30E-45FE-B420-6884D093B45D}"/>
            </c:ext>
          </c:extLst>
        </c:ser>
        <c:ser>
          <c:idx val="1"/>
          <c:order val="1"/>
          <c:tx>
            <c:strRef>
              <c:f>'SKL, HSC'!$B$17</c:f>
              <c:strCache>
                <c:ptCount val="1"/>
                <c:pt idx="0">
                  <c:v>FB-KO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SKL, HSC'!$D$18:$E$18</c:f>
                <c:numCache>
                  <c:formatCode>General</c:formatCode>
                  <c:ptCount val="2"/>
                  <c:pt idx="0">
                    <c:v>0.54678318639898016</c:v>
                  </c:pt>
                  <c:pt idx="1">
                    <c:v>3.8235209522892579</c:v>
                  </c:pt>
                </c:numCache>
              </c:numRef>
            </c:plus>
            <c:minus>
              <c:numRef>
                <c:f>'SKL, HSC'!$D$18:$E$18</c:f>
                <c:numCache>
                  <c:formatCode>General</c:formatCode>
                  <c:ptCount val="2"/>
                  <c:pt idx="0">
                    <c:v>0.54678318639898016</c:v>
                  </c:pt>
                  <c:pt idx="1">
                    <c:v>3.8235209522892579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'!$D$14:$E$14</c:f>
              <c:strCache>
                <c:ptCount val="2"/>
                <c:pt idx="0">
                  <c:v>No. of SKL/µl PB</c:v>
                </c:pt>
                <c:pt idx="1">
                  <c:v>No. of HSC/µl PB</c:v>
                </c:pt>
              </c:strCache>
            </c:strRef>
          </c:cat>
          <c:val>
            <c:numRef>
              <c:f>'SKL, HSC'!$D$17:$E$17</c:f>
              <c:numCache>
                <c:formatCode>0</c:formatCode>
                <c:ptCount val="2"/>
                <c:pt idx="0" formatCode="0.00">
                  <c:v>1.3464824687943491</c:v>
                </c:pt>
                <c:pt idx="1">
                  <c:v>52.8449703468792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30E-45FE-B420-6884D093B4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642048"/>
        <c:axId val="82643584"/>
      </c:barChart>
      <c:catAx>
        <c:axId val="82642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82643584"/>
        <c:crosses val="autoZero"/>
        <c:auto val="1"/>
        <c:lblAlgn val="ctr"/>
        <c:lblOffset val="100"/>
        <c:noMultiLvlLbl val="0"/>
      </c:catAx>
      <c:valAx>
        <c:axId val="82643584"/>
        <c:scaling>
          <c:orientation val="minMax"/>
          <c:max val="5"/>
        </c:scaling>
        <c:delete val="0"/>
        <c:axPos val="l"/>
        <c:numFmt formatCode="0.00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826420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13451443569554"/>
          <c:y val="9.0033027294971354E-2"/>
          <c:w val="0.63297594050743655"/>
          <c:h val="0.819933945410057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KL, HSC'!$B$1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28575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28575">
                <a:noFill/>
              </a:ln>
            </c:spPr>
            <c:extLst>
              <c:ext xmlns:c16="http://schemas.microsoft.com/office/drawing/2014/chart" uri="{C3380CC4-5D6E-409C-BE32-E72D297353CC}">
                <c16:uniqueId val="{00000000-24EC-45D2-A8C9-EB4D0550077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24EC-45D2-A8C9-EB4D05500774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24EC-45D2-A8C9-EB4D05500774}"/>
              </c:ext>
            </c:extLst>
          </c:dPt>
          <c:errBars>
            <c:errBarType val="plus"/>
            <c:errValType val="cust"/>
            <c:noEndCap val="0"/>
            <c:plus>
              <c:numRef>
                <c:f>'SKL, HSC'!$D$16:$E$16</c:f>
                <c:numCache>
                  <c:formatCode>General</c:formatCode>
                  <c:ptCount val="2"/>
                  <c:pt idx="0">
                    <c:v>0.17888133521666538</c:v>
                  </c:pt>
                  <c:pt idx="1">
                    <c:v>7.0209207777736342</c:v>
                  </c:pt>
                </c:numCache>
              </c:numRef>
            </c:plus>
            <c:minus>
              <c:numRef>
                <c:f>'SKL, HSC'!$D$16:$E$16</c:f>
                <c:numCache>
                  <c:formatCode>General</c:formatCode>
                  <c:ptCount val="2"/>
                  <c:pt idx="0">
                    <c:v>0.17888133521666538</c:v>
                  </c:pt>
                  <c:pt idx="1">
                    <c:v>7.0209207777736342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'!$D$14:$E$14</c:f>
              <c:strCache>
                <c:ptCount val="2"/>
                <c:pt idx="0">
                  <c:v>No. of SKL/µL PB</c:v>
                </c:pt>
                <c:pt idx="1">
                  <c:v>No. of HSC/µL PB</c:v>
                </c:pt>
              </c:strCache>
            </c:strRef>
          </c:cat>
          <c:val>
            <c:numRef>
              <c:f>'SKL, HSC'!$D$15:$E$15</c:f>
              <c:numCache>
                <c:formatCode>0</c:formatCode>
                <c:ptCount val="2"/>
                <c:pt idx="0" formatCode="0.00">
                  <c:v>1.4330978613147618</c:v>
                </c:pt>
                <c:pt idx="1">
                  <c:v>59.4066096986103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4EC-45D2-A8C9-EB4D05500774}"/>
            </c:ext>
          </c:extLst>
        </c:ser>
        <c:ser>
          <c:idx val="1"/>
          <c:order val="1"/>
          <c:tx>
            <c:strRef>
              <c:f>'SKL, HSC'!$B$17</c:f>
              <c:strCache>
                <c:ptCount val="1"/>
                <c:pt idx="0">
                  <c:v>FB-KO</c:v>
                </c:pt>
              </c:strCache>
            </c:strRef>
          </c:tx>
          <c:spPr>
            <a:solidFill>
              <a:schemeClr val="tx1"/>
            </a:solidFill>
            <a:ln w="28575">
              <a:solidFill>
                <a:schemeClr val="bg1">
                  <a:lumMod val="50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28575">
                <a:noFill/>
              </a:ln>
            </c:spPr>
            <c:extLst>
              <c:ext xmlns:c16="http://schemas.microsoft.com/office/drawing/2014/chart" uri="{C3380CC4-5D6E-409C-BE32-E72D297353CC}">
                <c16:uniqueId val="{00000005-24EC-45D2-A8C9-EB4D0550077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6-24EC-45D2-A8C9-EB4D05500774}"/>
              </c:ext>
            </c:extLst>
          </c:dPt>
          <c:errBars>
            <c:errBarType val="plus"/>
            <c:errValType val="cust"/>
            <c:noEndCap val="0"/>
            <c:plus>
              <c:numRef>
                <c:f>'SKL, HSC'!$D$18:$E$18</c:f>
                <c:numCache>
                  <c:formatCode>General</c:formatCode>
                  <c:ptCount val="2"/>
                  <c:pt idx="0">
                    <c:v>0.54678318639898016</c:v>
                  </c:pt>
                  <c:pt idx="1">
                    <c:v>3.8235209522892579</c:v>
                  </c:pt>
                </c:numCache>
              </c:numRef>
            </c:plus>
            <c:minus>
              <c:numRef>
                <c:f>'SKL, HSC'!$D$18:$E$18</c:f>
                <c:numCache>
                  <c:formatCode>General</c:formatCode>
                  <c:ptCount val="2"/>
                  <c:pt idx="0">
                    <c:v>0.54678318639898016</c:v>
                  </c:pt>
                  <c:pt idx="1">
                    <c:v>3.8235209522892579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'!$D$14:$E$14</c:f>
              <c:strCache>
                <c:ptCount val="2"/>
                <c:pt idx="0">
                  <c:v>No. of SKL/µL PB</c:v>
                </c:pt>
                <c:pt idx="1">
                  <c:v>No. of HSC/µL PB</c:v>
                </c:pt>
              </c:strCache>
            </c:strRef>
          </c:cat>
          <c:val>
            <c:numRef>
              <c:f>'SKL, HSC'!$D$17:$E$17</c:f>
              <c:numCache>
                <c:formatCode>0</c:formatCode>
                <c:ptCount val="2"/>
                <c:pt idx="0" formatCode="0.00">
                  <c:v>1.3464824687943491</c:v>
                </c:pt>
                <c:pt idx="1">
                  <c:v>52.8449703468792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4EC-45D2-A8C9-EB4D055007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642048"/>
        <c:axId val="82643584"/>
      </c:barChart>
      <c:catAx>
        <c:axId val="8264204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2643584"/>
        <c:crosses val="autoZero"/>
        <c:auto val="1"/>
        <c:lblAlgn val="ctr"/>
        <c:lblOffset val="100"/>
        <c:noMultiLvlLbl val="0"/>
      </c:catAx>
      <c:valAx>
        <c:axId val="82643584"/>
        <c:scaling>
          <c:orientation val="minMax"/>
          <c:min val="50"/>
        </c:scaling>
        <c:delete val="0"/>
        <c:axPos val="l"/>
        <c:numFmt formatCode="0.00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826420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4087401574803136"/>
          <c:y val="0.68624875040406952"/>
          <c:w val="0.19801487314085739"/>
          <c:h val="0.2995521586230459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90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4A4C-47C6-BAE0-9FBF14918E7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2-4A4C-47C6-BAE0-9FBF14918E75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4A4C-47C6-BAE0-9FBF14918E7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5-4A4C-47C6-BAE0-9FBF14918E75}"/>
              </c:ext>
            </c:extLst>
          </c:dPt>
          <c:errBars>
            <c:errBarType val="plus"/>
            <c:errValType val="cust"/>
            <c:noEndCap val="0"/>
            <c:plus>
              <c:numRef>
                <c:f>'CFU-GM E Meg'!$K$6:$N$6</c:f>
                <c:numCache>
                  <c:formatCode>General</c:formatCode>
                  <c:ptCount val="4"/>
                  <c:pt idx="0">
                    <c:v>16.969442073495411</c:v>
                  </c:pt>
                  <c:pt idx="1">
                    <c:v>11.999879091652785</c:v>
                  </c:pt>
                  <c:pt idx="2">
                    <c:v>6.3220136936625781</c:v>
                  </c:pt>
                  <c:pt idx="3">
                    <c:v>8.3863302888859383</c:v>
                  </c:pt>
                </c:numCache>
              </c:numRef>
            </c:plus>
            <c:minus>
              <c:numRef>
                <c:f>'CFU-GM E Meg'!$K$6:$N$6</c:f>
                <c:numCache>
                  <c:formatCode>General</c:formatCode>
                  <c:ptCount val="4"/>
                  <c:pt idx="0">
                    <c:v>16.969442073495411</c:v>
                  </c:pt>
                  <c:pt idx="1">
                    <c:v>11.999879091652785</c:v>
                  </c:pt>
                  <c:pt idx="2">
                    <c:v>6.3220136936625781</c:v>
                  </c:pt>
                  <c:pt idx="3">
                    <c:v>8.3863302888859383</c:v>
                  </c:pt>
                </c:numCache>
              </c:numRef>
            </c:minus>
            <c:spPr>
              <a:ln w="19050" cap="sq"/>
            </c:spPr>
          </c:errBars>
          <c:cat>
            <c:multiLvlStrRef>
              <c:f>'CFU-GM E Meg'!$K$3:$N$4</c:f>
              <c:multiLvlStrCache>
                <c:ptCount val="4"/>
                <c:lvl>
                  <c:pt idx="0">
                    <c:v>WT</c:v>
                  </c:pt>
                  <c:pt idx="1">
                    <c:v>FB-KO</c:v>
                  </c:pt>
                  <c:pt idx="2">
                    <c:v>WT</c:v>
                  </c:pt>
                  <c:pt idx="3">
                    <c:v>FB-KO</c:v>
                  </c:pt>
                </c:lvl>
                <c:lvl>
                  <c:pt idx="0">
                    <c:v>CFU-GM</c:v>
                  </c:pt>
                  <c:pt idx="2">
                    <c:v>BFU-E</c:v>
                  </c:pt>
                </c:lvl>
              </c:multiLvlStrCache>
            </c:multiLvlStrRef>
          </c:cat>
          <c:val>
            <c:numRef>
              <c:f>'CFU-GM E Meg'!$K$5:$N$5</c:f>
              <c:numCache>
                <c:formatCode>0.00</c:formatCode>
                <c:ptCount val="4"/>
                <c:pt idx="0">
                  <c:v>135.13749999999999</c:v>
                </c:pt>
                <c:pt idx="1">
                  <c:v>150.93125000000001</c:v>
                </c:pt>
                <c:pt idx="2">
                  <c:v>107.82499999999999</c:v>
                </c:pt>
                <c:pt idx="3">
                  <c:v>100.9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A4C-47C6-BAE0-9FBF14918E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642048"/>
        <c:axId val="82643584"/>
      </c:barChart>
      <c:catAx>
        <c:axId val="82642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82643584"/>
        <c:crosses val="autoZero"/>
        <c:auto val="1"/>
        <c:lblAlgn val="ctr"/>
        <c:lblOffset val="100"/>
        <c:noMultiLvlLbl val="0"/>
      </c:catAx>
      <c:valAx>
        <c:axId val="8264358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826420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89154917532979"/>
          <c:y val="8.2450333218854102E-2"/>
          <c:w val="0.65727874633769101"/>
          <c:h val="0.725109720972666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KL, HSC BM'!$B$1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190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5562-4B77-A437-E78462DCDD92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5562-4B77-A437-E78462DCDD92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5562-4B77-A437-E78462DCDD92}"/>
              </c:ext>
            </c:extLst>
          </c:dPt>
          <c:errBars>
            <c:errBarType val="plus"/>
            <c:errValType val="cust"/>
            <c:noEndCap val="0"/>
            <c:plus>
              <c:numRef>
                <c:f>'SKL, HSC BM'!$D$16:$E$16</c:f>
                <c:numCache>
                  <c:formatCode>General</c:formatCode>
                  <c:ptCount val="2"/>
                  <c:pt idx="0">
                    <c:v>8.0952450427206179E-3</c:v>
                  </c:pt>
                  <c:pt idx="1">
                    <c:v>0.26567881478821842</c:v>
                  </c:pt>
                </c:numCache>
              </c:numRef>
            </c:plus>
            <c:minus>
              <c:numRef>
                <c:f>'SKL, HSC BM'!$D$16:$E$16</c:f>
                <c:numCache>
                  <c:formatCode>General</c:formatCode>
                  <c:ptCount val="2"/>
                  <c:pt idx="0">
                    <c:v>8.0952450427206179E-3</c:v>
                  </c:pt>
                  <c:pt idx="1">
                    <c:v>0.26567881478821842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 BM'!$D$14:$E$14</c:f>
              <c:strCache>
                <c:ptCount val="2"/>
                <c:pt idx="0">
                  <c:v>% of SKL (BM)</c:v>
                </c:pt>
                <c:pt idx="1">
                  <c:v>% of HSC (BM)</c:v>
                </c:pt>
              </c:strCache>
            </c:strRef>
          </c:cat>
          <c:val>
            <c:numRef>
              <c:f>'SKL, HSC BM'!$D$15:$E$15</c:f>
              <c:numCache>
                <c:formatCode>0.0000</c:formatCode>
                <c:ptCount val="2"/>
                <c:pt idx="0">
                  <c:v>2.7612613340792874E-2</c:v>
                </c:pt>
                <c:pt idx="1">
                  <c:v>1.48536814401152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562-4B77-A437-E78462DCDD92}"/>
            </c:ext>
          </c:extLst>
        </c:ser>
        <c:ser>
          <c:idx val="1"/>
          <c:order val="1"/>
          <c:tx>
            <c:strRef>
              <c:f>'SKL, HSC BM'!$B$17</c:f>
              <c:strCache>
                <c:ptCount val="1"/>
                <c:pt idx="0">
                  <c:v>FB-KO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SKL, HSC BM'!$D$18:$E$18</c:f>
                <c:numCache>
                  <c:formatCode>General</c:formatCode>
                  <c:ptCount val="2"/>
                  <c:pt idx="0">
                    <c:v>1.3149286530588335E-2</c:v>
                  </c:pt>
                  <c:pt idx="1">
                    <c:v>0.33735959047581088</c:v>
                  </c:pt>
                </c:numCache>
              </c:numRef>
            </c:plus>
            <c:minus>
              <c:numRef>
                <c:f>'SKL, HSC BM'!$D$18:$E$18</c:f>
                <c:numCache>
                  <c:formatCode>General</c:formatCode>
                  <c:ptCount val="2"/>
                  <c:pt idx="0">
                    <c:v>1.3149286530588335E-2</c:v>
                  </c:pt>
                  <c:pt idx="1">
                    <c:v>0.33735959047581088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 BM'!$D$14:$E$14</c:f>
              <c:strCache>
                <c:ptCount val="2"/>
                <c:pt idx="0">
                  <c:v>% of SKL (BM)</c:v>
                </c:pt>
                <c:pt idx="1">
                  <c:v>% of HSC (BM)</c:v>
                </c:pt>
              </c:strCache>
            </c:strRef>
          </c:cat>
          <c:val>
            <c:numRef>
              <c:f>'SKL, HSC BM'!$D$17:$E$17</c:f>
              <c:numCache>
                <c:formatCode>0.0000</c:formatCode>
                <c:ptCount val="2"/>
                <c:pt idx="0">
                  <c:v>3.1307791900372056E-2</c:v>
                </c:pt>
                <c:pt idx="1">
                  <c:v>1.5526599222797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562-4B77-A437-E78462DCDD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642048"/>
        <c:axId val="82643584"/>
      </c:barChart>
      <c:catAx>
        <c:axId val="82642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82643584"/>
        <c:crosses val="autoZero"/>
        <c:auto val="1"/>
        <c:lblAlgn val="ctr"/>
        <c:lblOffset val="100"/>
        <c:noMultiLvlLbl val="0"/>
      </c:catAx>
      <c:valAx>
        <c:axId val="82643584"/>
        <c:scaling>
          <c:orientation val="minMax"/>
          <c:max val="5.000000000000001E-2"/>
        </c:scaling>
        <c:delete val="0"/>
        <c:axPos val="l"/>
        <c:numFmt formatCode="0.0000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826420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KL, HSC BM'!$B$1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190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noFill/>
              </a:ln>
            </c:spPr>
            <c:extLst>
              <c:ext xmlns:c16="http://schemas.microsoft.com/office/drawing/2014/chart" uri="{C3380CC4-5D6E-409C-BE32-E72D297353CC}">
                <c16:uniqueId val="{00000000-AC45-456A-8AB6-6CF4EB84F134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AC45-456A-8AB6-6CF4EB84F134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AC45-456A-8AB6-6CF4EB84F134}"/>
              </c:ext>
            </c:extLst>
          </c:dPt>
          <c:errBars>
            <c:errBarType val="plus"/>
            <c:errValType val="cust"/>
            <c:noEndCap val="0"/>
            <c:plus>
              <c:numRef>
                <c:f>'SKL, HSC BM'!$D$16:$E$16</c:f>
                <c:numCache>
                  <c:formatCode>General</c:formatCode>
                  <c:ptCount val="2"/>
                  <c:pt idx="0">
                    <c:v>8.0952450427206179E-3</c:v>
                  </c:pt>
                  <c:pt idx="1">
                    <c:v>0.26567881478821842</c:v>
                  </c:pt>
                </c:numCache>
              </c:numRef>
            </c:plus>
            <c:minus>
              <c:numRef>
                <c:f>'SKL, HSC BM'!$D$16:$E$16</c:f>
                <c:numCache>
                  <c:formatCode>General</c:formatCode>
                  <c:ptCount val="2"/>
                  <c:pt idx="0">
                    <c:v>8.0952450427206179E-3</c:v>
                  </c:pt>
                  <c:pt idx="1">
                    <c:v>0.26567881478821842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 BM'!$D$14:$E$14</c:f>
              <c:strCache>
                <c:ptCount val="2"/>
                <c:pt idx="0">
                  <c:v>% of SKL (BM)</c:v>
                </c:pt>
                <c:pt idx="1">
                  <c:v>% of HSC (BM)</c:v>
                </c:pt>
              </c:strCache>
            </c:strRef>
          </c:cat>
          <c:val>
            <c:numRef>
              <c:f>'SKL, HSC BM'!$D$15:$E$15</c:f>
              <c:numCache>
                <c:formatCode>0.0000</c:formatCode>
                <c:ptCount val="2"/>
                <c:pt idx="0">
                  <c:v>2.7612613340792874E-2</c:v>
                </c:pt>
                <c:pt idx="1">
                  <c:v>1.48536814401152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C45-456A-8AB6-6CF4EB84F134}"/>
            </c:ext>
          </c:extLst>
        </c:ser>
        <c:ser>
          <c:idx val="1"/>
          <c:order val="1"/>
          <c:tx>
            <c:strRef>
              <c:f>'SKL, HSC BM'!$B$17</c:f>
              <c:strCache>
                <c:ptCount val="1"/>
                <c:pt idx="0">
                  <c:v>FB-KO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noFill/>
              </a:ln>
            </c:spPr>
            <c:extLst>
              <c:ext xmlns:c16="http://schemas.microsoft.com/office/drawing/2014/chart" uri="{C3380CC4-5D6E-409C-BE32-E72D297353CC}">
                <c16:uniqueId val="{00000005-AC45-456A-8AB6-6CF4EB84F134}"/>
              </c:ext>
            </c:extLst>
          </c:dPt>
          <c:errBars>
            <c:errBarType val="plus"/>
            <c:errValType val="cust"/>
            <c:noEndCap val="0"/>
            <c:plus>
              <c:numRef>
                <c:f>'SKL, HSC BM'!$D$18:$E$18</c:f>
                <c:numCache>
                  <c:formatCode>General</c:formatCode>
                  <c:ptCount val="2"/>
                  <c:pt idx="0">
                    <c:v>1.3149286530588335E-2</c:v>
                  </c:pt>
                  <c:pt idx="1">
                    <c:v>0.33735959047581088</c:v>
                  </c:pt>
                </c:numCache>
              </c:numRef>
            </c:plus>
            <c:minus>
              <c:numRef>
                <c:f>'SKL, HSC BM'!$D$18:$E$18</c:f>
                <c:numCache>
                  <c:formatCode>General</c:formatCode>
                  <c:ptCount val="2"/>
                  <c:pt idx="0">
                    <c:v>1.3149286530588335E-2</c:v>
                  </c:pt>
                  <c:pt idx="1">
                    <c:v>0.33735959047581088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SKL, HSC BM'!$D$14:$E$14</c:f>
              <c:strCache>
                <c:ptCount val="2"/>
                <c:pt idx="0">
                  <c:v>% of SKL (BM)</c:v>
                </c:pt>
                <c:pt idx="1">
                  <c:v>% of HSC (BM)</c:v>
                </c:pt>
              </c:strCache>
            </c:strRef>
          </c:cat>
          <c:val>
            <c:numRef>
              <c:f>'SKL, HSC BM'!$D$17:$E$17</c:f>
              <c:numCache>
                <c:formatCode>0.0000</c:formatCode>
                <c:ptCount val="2"/>
                <c:pt idx="0">
                  <c:v>3.1307791900372056E-2</c:v>
                </c:pt>
                <c:pt idx="1">
                  <c:v>1.5526599222797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C45-456A-8AB6-6CF4EB84F1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642048"/>
        <c:axId val="82643584"/>
      </c:barChart>
      <c:catAx>
        <c:axId val="8264204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2643584"/>
        <c:crosses val="autoZero"/>
        <c:auto val="1"/>
        <c:lblAlgn val="ctr"/>
        <c:lblOffset val="100"/>
        <c:noMultiLvlLbl val="0"/>
      </c:catAx>
      <c:valAx>
        <c:axId val="82643584"/>
        <c:scaling>
          <c:orientation val="minMax"/>
          <c:min val="1"/>
        </c:scaling>
        <c:delete val="0"/>
        <c:axPos val="l"/>
        <c:numFmt formatCode="0.0000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826420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1678717894376773"/>
          <c:y val="0.6587115904554468"/>
          <c:w val="0.1448468801588364"/>
          <c:h val="0.3338196288172379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3462B4-9928-45E5-A9A7-F27AA725CA8E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1F2545-CD74-4B24-B4D1-E27F023AA46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21744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08438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598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68141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13006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9484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21174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12514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79904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67478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69665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92313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66663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07894" y="228600"/>
            <a:ext cx="7395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84093" y="4212516"/>
            <a:ext cx="4034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grpSp>
        <p:nvGrpSpPr>
          <p:cNvPr id="11" name="Grupa 10">
            <a:extLst>
              <a:ext uri="{FF2B5EF4-FFF2-40B4-BE49-F238E27FC236}">
                <a16:creationId xmlns:a16="http://schemas.microsoft.com/office/drawing/2014/main" id="{5281BF5E-F38C-42A7-BE32-8C4ADCC052DD}"/>
              </a:ext>
            </a:extLst>
          </p:cNvPr>
          <p:cNvGrpSpPr/>
          <p:nvPr/>
        </p:nvGrpSpPr>
        <p:grpSpPr>
          <a:xfrm>
            <a:off x="5173579" y="332874"/>
            <a:ext cx="4047706" cy="3378336"/>
            <a:chOff x="4384877" y="181008"/>
            <a:chExt cx="4572000" cy="3378336"/>
          </a:xfrm>
        </p:grpSpPr>
        <p:graphicFrame>
          <p:nvGraphicFramePr>
            <p:cNvPr id="9" name="Chart 8">
              <a:extLst>
                <a:ext uri="{FF2B5EF4-FFF2-40B4-BE49-F238E27FC236}">
                  <a16:creationId xmlns:a16="http://schemas.microsoft.com/office/drawing/2014/main" id="{00000000-0008-0000-0100-000009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70636832"/>
                </p:ext>
              </p:extLst>
            </p:nvPr>
          </p:nvGraphicFramePr>
          <p:xfrm>
            <a:off x="4384877" y="1820782"/>
            <a:ext cx="4572000" cy="17385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0" name="Chart 8">
              <a:extLst>
                <a:ext uri="{FF2B5EF4-FFF2-40B4-BE49-F238E27FC236}">
                  <a16:creationId xmlns:a16="http://schemas.microsoft.com/office/drawing/2014/main" id="{6860E0DE-14D1-4FD8-8EFD-47C9F96466B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13237925"/>
                </p:ext>
              </p:extLst>
            </p:nvPr>
          </p:nvGraphicFramePr>
          <p:xfrm>
            <a:off x="4384877" y="181008"/>
            <a:ext cx="4572000" cy="17385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aphicFrame>
        <p:nvGraphicFramePr>
          <p:cNvPr id="12" name="Chart 8">
            <a:extLst>
              <a:ext uri="{FF2B5EF4-FFF2-40B4-BE49-F238E27FC236}">
                <a16:creationId xmlns:a16="http://schemas.microsoft.com/office/drawing/2014/main" id="{00000000-0008-0000-0200-000009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6930469"/>
              </p:ext>
            </p:extLst>
          </p:nvPr>
        </p:nvGraphicFramePr>
        <p:xfrm>
          <a:off x="990468" y="3871100"/>
          <a:ext cx="7487785" cy="24286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5" name="Grupa 14">
            <a:extLst>
              <a:ext uri="{FF2B5EF4-FFF2-40B4-BE49-F238E27FC236}">
                <a16:creationId xmlns:a16="http://schemas.microsoft.com/office/drawing/2014/main" id="{24891E1A-40A6-4E75-AD3F-6333891BFE6E}"/>
              </a:ext>
            </a:extLst>
          </p:cNvPr>
          <p:cNvGrpSpPr/>
          <p:nvPr/>
        </p:nvGrpSpPr>
        <p:grpSpPr>
          <a:xfrm>
            <a:off x="870283" y="332874"/>
            <a:ext cx="4303296" cy="3378336"/>
            <a:chOff x="685799" y="332874"/>
            <a:chExt cx="4303296" cy="3378336"/>
          </a:xfrm>
        </p:grpSpPr>
        <p:graphicFrame>
          <p:nvGraphicFramePr>
            <p:cNvPr id="13" name="Chart 8">
              <a:extLst>
                <a:ext uri="{FF2B5EF4-FFF2-40B4-BE49-F238E27FC236}">
                  <a16:creationId xmlns:a16="http://schemas.microsoft.com/office/drawing/2014/main" id="{6E4AEDE2-A7B3-46DD-8068-18A887F3D61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91254627"/>
                </p:ext>
              </p:extLst>
            </p:nvPr>
          </p:nvGraphicFramePr>
          <p:xfrm>
            <a:off x="685799" y="1812758"/>
            <a:ext cx="4303296" cy="189845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4" name="Chart 8">
              <a:extLst>
                <a:ext uri="{FF2B5EF4-FFF2-40B4-BE49-F238E27FC236}">
                  <a16:creationId xmlns:a16="http://schemas.microsoft.com/office/drawing/2014/main" id="{BCCDA79F-0941-470D-AF05-137BCD96470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61890"/>
                </p:ext>
              </p:extLst>
            </p:nvPr>
          </p:nvGraphicFramePr>
          <p:xfrm>
            <a:off x="685799" y="332874"/>
            <a:ext cx="4303296" cy="156009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16" name="TextBox 5">
            <a:extLst>
              <a:ext uri="{FF2B5EF4-FFF2-40B4-BE49-F238E27FC236}">
                <a16:creationId xmlns:a16="http://schemas.microsoft.com/office/drawing/2014/main" id="{CB99E907-1B1F-4C8D-B3AC-2BCB96BD8409}"/>
              </a:ext>
            </a:extLst>
          </p:cNvPr>
          <p:cNvSpPr txBox="1"/>
          <p:nvPr/>
        </p:nvSpPr>
        <p:spPr>
          <a:xfrm>
            <a:off x="5886651" y="6459602"/>
            <a:ext cx="3151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      </a:t>
            </a:r>
            <a:r>
              <a:rPr lang="pl-PL" b="1" dirty="0" smtClean="0"/>
              <a:t>Supplementa</a:t>
            </a:r>
            <a:r>
              <a:rPr lang="en-US" b="1" dirty="0" smtClean="0"/>
              <a:t>r</a:t>
            </a:r>
            <a:r>
              <a:rPr lang="pl-PL" b="1" dirty="0" smtClean="0"/>
              <a:t>y </a:t>
            </a:r>
            <a:r>
              <a:rPr lang="en-US" b="1" dirty="0"/>
              <a:t>Figure </a:t>
            </a:r>
            <a:r>
              <a:rPr lang="en-US" b="1" dirty="0" smtClean="0"/>
              <a:t>1 </a:t>
            </a:r>
            <a:r>
              <a:rPr lang="pl-PL" b="1" dirty="0" smtClean="0"/>
              <a:t>B,C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099356675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7</TotalTime>
  <Words>9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wum</dc:creator>
  <cp:lastModifiedBy>Ratajczak,Mariusz</cp:lastModifiedBy>
  <cp:revision>92</cp:revision>
  <dcterms:created xsi:type="dcterms:W3CDTF">2019-01-18T11:33:21Z</dcterms:created>
  <dcterms:modified xsi:type="dcterms:W3CDTF">2019-05-06T15:09:18Z</dcterms:modified>
</cp:coreProperties>
</file>